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E4F4F-C042-477B-B030-F037C1DB75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A85BDB-1C8E-46B4-82DB-61E7D1BF0B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CCF6C-9FDD-4551-A22E-EDF0A07D6F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7CEAB-B479-4604-871B-344F19EDB5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B9616-D4EA-4CA7-9BD1-449DC1B5C4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80212-4F5E-4A97-92AF-91C0902CC7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A42D9-1BED-41EA-BEB7-67869EC4F2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03109A-2D26-4B36-9B0B-4D3F433DBE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A3AA9-7DBE-414E-92BD-283639EE42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8D625-40BA-48F1-A70E-E60C49966B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40A01-C425-4AE4-B5CC-3E27D2E3AA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B0D721-4EA0-4E5D-A576-7EB7E01373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14ACCF-80F9-420E-B929-4A2DAC4D468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32760" y="3425760"/>
            <a:ext cx="4392000" cy="3100680"/>
            <a:chOff x="-32760" y="3425760"/>
            <a:chExt cx="4392000" cy="3100680"/>
          </a:xfrm>
        </p:grpSpPr>
        <p:grpSp>
          <p:nvGrpSpPr>
            <p:cNvPr id="42" name=""/>
            <p:cNvGrpSpPr/>
            <p:nvPr/>
          </p:nvGrpSpPr>
          <p:grpSpPr>
            <a:xfrm>
              <a:off x="-32760" y="3425760"/>
              <a:ext cx="4392000" cy="3100680"/>
              <a:chOff x="-32760" y="3425760"/>
              <a:chExt cx="4392000" cy="3100680"/>
            </a:xfrm>
          </p:grpSpPr>
          <p:sp>
            <p:nvSpPr>
              <p:cNvPr id="43" name=""/>
              <p:cNvSpPr/>
              <p:nvPr/>
            </p:nvSpPr>
            <p:spPr>
              <a:xfrm>
                <a:off x="546120" y="3508200"/>
                <a:ext cx="3703680" cy="2384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546120" y="5297400"/>
                <a:ext cx="3703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46120" y="4700520"/>
                <a:ext cx="3703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546120" y="4105080"/>
                <a:ext cx="3703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46120" y="3508200"/>
                <a:ext cx="37036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546120" y="3508200"/>
                <a:ext cx="3703680" cy="2384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604800" y="3960720"/>
                <a:ext cx="47520" cy="19317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709560" y="3966840"/>
                <a:ext cx="57240" cy="19256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843120" y="4311360"/>
                <a:ext cx="45720" cy="15811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966960" y="4632120"/>
                <a:ext cx="55440" cy="12603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100160" y="4914720"/>
                <a:ext cx="47520" cy="9777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224000" y="5105160"/>
                <a:ext cx="46080" cy="7873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349280" y="5297400"/>
                <a:ext cx="55800" cy="5950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482840" y="5475240"/>
                <a:ext cx="47520" cy="417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608120" y="5717880"/>
                <a:ext cx="44640" cy="1746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1730520" y="5717880"/>
                <a:ext cx="56880" cy="1746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863720" y="5611680"/>
                <a:ext cx="47520" cy="2808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46120" y="58924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46120" y="57178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46120" y="5611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546120" y="55353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546120" y="54752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546120" y="54259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546120" y="53895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46120" y="5357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546120" y="53276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546120" y="52974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46120" y="5121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546120" y="50148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546120" y="49384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546120" y="48765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46120" y="48304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46120" y="47941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546120" y="47606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46120" y="47322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46120" y="4700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546120" y="45259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46120" y="44179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46120" y="43416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546120" y="4279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546120" y="42336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546120" y="41972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46120" y="41655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46120" y="4133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546120" y="41050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546120" y="39290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546120" y="38224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546120" y="37447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546120" y="36846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46120" y="3638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46120" y="36003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546120" y="35701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546120" y="35384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46120" y="35082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546120" y="5892480"/>
                <a:ext cx="39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546120" y="5297400"/>
                <a:ext cx="39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546120" y="4700520"/>
                <a:ext cx="39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546120" y="4105080"/>
                <a:ext cx="39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546120" y="3508200"/>
                <a:ext cx="39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54612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 flipV="1">
                <a:off x="6732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8031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 flipV="1">
                <a:off x="9288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10605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 flipV="1">
                <a:off x="118584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V="1">
                <a:off x="131112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flipV="1">
                <a:off x="144288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V="1">
                <a:off x="156672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V="1">
                <a:off x="16938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V="1">
                <a:off x="182412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 flipV="1">
                <a:off x="19494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20829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 flipV="1">
                <a:off x="22068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233208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 flipV="1">
                <a:off x="246528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flipV="1">
                <a:off x="258768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V="1">
                <a:off x="27147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 flipV="1">
                <a:off x="284652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 flipV="1">
                <a:off x="29703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V="1">
                <a:off x="31050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 flipV="1">
                <a:off x="322884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V="1">
                <a:off x="335268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 flipV="1">
                <a:off x="348624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 flipV="1">
                <a:off x="361008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 flipV="1">
                <a:off x="37353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386892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 flipV="1">
                <a:off x="39924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412416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V="1">
                <a:off x="4249800" y="585576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21560" y="581184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76920" y="521496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02040" y="461772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19600" y="402264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177840" y="3425760"/>
                <a:ext cx="32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327320" y="6249960"/>
                <a:ext cx="2073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</a:rPr>
                  <a:t>Length of predicted CDS (bp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-32760" y="4349520"/>
                <a:ext cx="362880" cy="118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Number of CD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42080" y="5946480"/>
                <a:ext cx="332640" cy="351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673920" y="5946480"/>
                <a:ext cx="332640" cy="351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951480" y="5946480"/>
                <a:ext cx="332640" cy="351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207080" y="5954400"/>
                <a:ext cx="332640" cy="35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465920" y="5946480"/>
                <a:ext cx="332640" cy="351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705680" y="5954400"/>
                <a:ext cx="332640" cy="35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983600" y="5954400"/>
                <a:ext cx="332640" cy="35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235960" y="5954400"/>
                <a:ext cx="332640" cy="35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481840" y="5954400"/>
                <a:ext cx="332640" cy="35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740680" y="5952960"/>
                <a:ext cx="332640" cy="35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013920" y="5946480"/>
                <a:ext cx="332640" cy="351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255120" y="5935680"/>
                <a:ext cx="332640" cy="352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494880" y="5937120"/>
                <a:ext cx="332640" cy="350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3774240" y="5937120"/>
                <a:ext cx="332640" cy="350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026600" y="5954400"/>
                <a:ext cx="332640" cy="360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4" name=""/>
            <p:cNvSpPr/>
            <p:nvPr/>
          </p:nvSpPr>
          <p:spPr>
            <a:xfrm>
              <a:off x="3600360" y="3641400"/>
              <a:ext cx="3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5" name=""/>
          <p:cNvGrpSpPr/>
          <p:nvPr/>
        </p:nvGrpSpPr>
        <p:grpSpPr>
          <a:xfrm>
            <a:off x="4431240" y="3465360"/>
            <a:ext cx="4679280" cy="3060720"/>
            <a:chOff x="4431240" y="3465360"/>
            <a:chExt cx="4679280" cy="3060720"/>
          </a:xfrm>
        </p:grpSpPr>
        <p:sp>
          <p:nvSpPr>
            <p:cNvPr id="156" name=""/>
            <p:cNvSpPr/>
            <p:nvPr/>
          </p:nvSpPr>
          <p:spPr>
            <a:xfrm>
              <a:off x="4431240" y="4149720"/>
              <a:ext cx="36288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umber of CD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7" name=""/>
            <p:cNvGrpSpPr/>
            <p:nvPr/>
          </p:nvGrpSpPr>
          <p:grpSpPr>
            <a:xfrm>
              <a:off x="4641840" y="3465360"/>
              <a:ext cx="4468680" cy="3060720"/>
              <a:chOff x="4641840" y="3465360"/>
              <a:chExt cx="4468680" cy="3060720"/>
            </a:xfrm>
          </p:grpSpPr>
          <p:sp>
            <p:nvSpPr>
              <p:cNvPr id="158" name=""/>
              <p:cNvSpPr/>
              <p:nvPr/>
            </p:nvSpPr>
            <p:spPr>
              <a:xfrm>
                <a:off x="5014800" y="3531960"/>
                <a:ext cx="3981600" cy="240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5014800" y="5332320"/>
                <a:ext cx="398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5014800" y="4732200"/>
                <a:ext cx="398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5014800" y="4132080"/>
                <a:ext cx="398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5014800" y="3531960"/>
                <a:ext cx="39816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5014800" y="3531960"/>
                <a:ext cx="3981600" cy="24001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5072040" y="3789000"/>
                <a:ext cx="47520" cy="21430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5176800" y="5360760"/>
                <a:ext cx="57240" cy="5713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5310360" y="5570280"/>
                <a:ext cx="47520" cy="3618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5434200" y="5465520"/>
                <a:ext cx="56880" cy="466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5567400" y="5189400"/>
                <a:ext cx="47520" cy="7426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5691240" y="5646600"/>
                <a:ext cx="57240" cy="2854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5824440" y="5227560"/>
                <a:ext cx="47880" cy="7045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5948280" y="5303520"/>
                <a:ext cx="57240" cy="628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6081840" y="5208480"/>
                <a:ext cx="47520" cy="7236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6205680" y="5151240"/>
                <a:ext cx="56880" cy="7808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6338880" y="5189400"/>
                <a:ext cx="47520" cy="7426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6462720" y="5179680"/>
                <a:ext cx="57240" cy="7524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6595920" y="5113080"/>
                <a:ext cx="47880" cy="8190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6719760" y="5189400"/>
                <a:ext cx="57240" cy="7426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6853320" y="5227560"/>
                <a:ext cx="47520" cy="7045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6977160" y="5046480"/>
                <a:ext cx="57240" cy="8856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7110360" y="5122800"/>
                <a:ext cx="47520" cy="8092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7234200" y="5246280"/>
                <a:ext cx="57240" cy="6858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7367760" y="5094000"/>
                <a:ext cx="47520" cy="8380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7491600" y="5122800"/>
                <a:ext cx="56880" cy="8092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7624800" y="5284440"/>
                <a:ext cx="47520" cy="6476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7748640" y="5465520"/>
                <a:ext cx="57240" cy="466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7881840" y="5389200"/>
                <a:ext cx="47880" cy="5428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8005680" y="5513040"/>
                <a:ext cx="57240" cy="4190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8139240" y="5513040"/>
                <a:ext cx="47520" cy="4190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5014800" y="593208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5014800" y="57513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5014800" y="56466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014800" y="557028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5014800" y="55130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5014800" y="54655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5014800" y="54273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5014800" y="53892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014800" y="53607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5014800" y="53323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5014800" y="51512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5014800" y="504648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5014800" y="49701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5014800" y="49129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014800" y="48654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5014800" y="48272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014800" y="478908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014800" y="47606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014800" y="47322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014800" y="45511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014800" y="44463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014800" y="43700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014800" y="43131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014800" y="426528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014800" y="42271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014800" y="41893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5014800" y="41605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5014800" y="413208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5014800" y="39510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5014800" y="38462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5014800" y="376992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014800" y="371304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5014800" y="36651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5014800" y="36273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5014800" y="35892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5014800" y="356040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5014800" y="3531960"/>
                <a:ext cx="38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5014800" y="5932080"/>
                <a:ext cx="478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5014800" y="5332320"/>
                <a:ext cx="478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5014800" y="4732200"/>
                <a:ext cx="478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5014800" y="4132080"/>
                <a:ext cx="478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5014800" y="3531960"/>
                <a:ext cx="478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 flipV="1">
                <a:off x="501480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 flipV="1">
                <a:off x="513864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 flipV="1">
                <a:off x="527220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V="1">
                <a:off x="539604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 flipV="1">
                <a:off x="552924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 flipV="1">
                <a:off x="565308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 flipV="1">
                <a:off x="578628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 flipV="1">
                <a:off x="59101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 flipV="1">
                <a:off x="604368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V="1">
                <a:off x="61675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 flipV="1">
                <a:off x="63007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 flipV="1">
                <a:off x="642456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 flipV="1">
                <a:off x="65581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 flipV="1">
                <a:off x="668196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 flipV="1">
                <a:off x="681516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 flipV="1">
                <a:off x="693900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 flipV="1">
                <a:off x="707220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 flipV="1">
                <a:off x="719604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 flipV="1">
                <a:off x="732960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 flipV="1">
                <a:off x="745344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 flipV="1">
                <a:off x="758664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 flipV="1">
                <a:off x="771048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 flipV="1">
                <a:off x="784368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 flipV="1">
                <a:off x="79675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 flipV="1">
                <a:off x="810108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 flipV="1">
                <a:off x="82249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 flipV="1">
                <a:off x="83581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 flipV="1">
                <a:off x="848196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 flipV="1">
                <a:off x="861552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 flipV="1">
                <a:off x="873936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 flipV="1">
                <a:off x="887256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 flipV="1">
                <a:off x="8996400" y="5884560"/>
                <a:ext cx="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4861800" y="586548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4785480" y="526536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4756680" y="466560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4699440" y="406548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4641840" y="3465360"/>
                <a:ext cx="32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4914000" y="5954400"/>
                <a:ext cx="332640" cy="216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5168160" y="5949720"/>
                <a:ext cx="332640" cy="360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0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5417280" y="595908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0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568224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0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594900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0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621252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646992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1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6714360" y="5964120"/>
                <a:ext cx="332640" cy="431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1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6977880" y="5964120"/>
                <a:ext cx="332640" cy="431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1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723816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1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750168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774612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800640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826992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852408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8777880" y="5954400"/>
                <a:ext cx="332640" cy="432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6086520" y="6249600"/>
                <a:ext cx="1727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GAP (N/size of CDS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8102520" y="3681000"/>
                <a:ext cx="36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86" name=""/>
          <p:cNvGrpSpPr/>
          <p:nvPr/>
        </p:nvGrpSpPr>
        <p:grpSpPr>
          <a:xfrm>
            <a:off x="-68040" y="44280"/>
            <a:ext cx="4374720" cy="2883600"/>
            <a:chOff x="-68040" y="44280"/>
            <a:chExt cx="4374720" cy="2883600"/>
          </a:xfrm>
        </p:grpSpPr>
        <p:grpSp>
          <p:nvGrpSpPr>
            <p:cNvPr id="287" name=""/>
            <p:cNvGrpSpPr/>
            <p:nvPr/>
          </p:nvGrpSpPr>
          <p:grpSpPr>
            <a:xfrm>
              <a:off x="-68040" y="44280"/>
              <a:ext cx="4374720" cy="2883600"/>
              <a:chOff x="-68040" y="44280"/>
              <a:chExt cx="4374720" cy="2883600"/>
            </a:xfrm>
          </p:grpSpPr>
          <p:sp>
            <p:nvSpPr>
              <p:cNvPr id="288" name=""/>
              <p:cNvSpPr/>
              <p:nvPr/>
            </p:nvSpPr>
            <p:spPr>
              <a:xfrm>
                <a:off x="581760" y="87480"/>
                <a:ext cx="3715920" cy="2238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581760" y="1583640"/>
                <a:ext cx="371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581760" y="829800"/>
                <a:ext cx="371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581760" y="87480"/>
                <a:ext cx="3715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581760" y="87480"/>
                <a:ext cx="3715920" cy="2238480"/>
              </a:xfrm>
              <a:prstGeom prst="rect">
                <a:avLst/>
              </a:prstGeom>
              <a:noFill/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637920" y="801000"/>
                <a:ext cx="51120" cy="15249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734400" y="810000"/>
                <a:ext cx="51480" cy="15159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856080" y="910080"/>
                <a:ext cx="60480" cy="14155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988560" y="991800"/>
                <a:ext cx="51120" cy="13341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1110240" y="1051920"/>
                <a:ext cx="51120" cy="127404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1231920" y="1111680"/>
                <a:ext cx="51120" cy="12139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1353240" y="1161360"/>
                <a:ext cx="51120" cy="116424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1476360" y="1212120"/>
                <a:ext cx="60480" cy="111384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1607040" y="1252440"/>
                <a:ext cx="51480" cy="10735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1728720" y="1292040"/>
                <a:ext cx="51480" cy="10335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1852200" y="1343160"/>
                <a:ext cx="49680" cy="98280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1973520" y="1372320"/>
                <a:ext cx="49680" cy="95328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2095200" y="1443600"/>
                <a:ext cx="60480" cy="8823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2227680" y="1483200"/>
                <a:ext cx="49680" cy="84240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2349000" y="1543320"/>
                <a:ext cx="50040" cy="78264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2470680" y="1563120"/>
                <a:ext cx="51480" cy="76248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2592360" y="1603440"/>
                <a:ext cx="51480" cy="7225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2713680" y="1632960"/>
                <a:ext cx="60480" cy="69300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2846520" y="1692720"/>
                <a:ext cx="49680" cy="63288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2967840" y="1734480"/>
                <a:ext cx="51480" cy="59148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3089520" y="1794600"/>
                <a:ext cx="51480" cy="5313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3211200" y="1794600"/>
                <a:ext cx="51480" cy="53136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3334320" y="1883880"/>
                <a:ext cx="60480" cy="4417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3465360" y="1914840"/>
                <a:ext cx="51120" cy="4111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3587040" y="1954800"/>
                <a:ext cx="51120" cy="37080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3709800" y="1974960"/>
                <a:ext cx="49680" cy="35100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3831480" y="2215080"/>
                <a:ext cx="49680" cy="11052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3953160" y="2145600"/>
                <a:ext cx="60480" cy="18000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4207320" y="1854720"/>
                <a:ext cx="49680" cy="471240"/>
              </a:xfrm>
              <a:prstGeom prst="rect">
                <a:avLst/>
              </a:prstGeom>
              <a:solidFill>
                <a:srgbClr val="0000ff"/>
              </a:solidFill>
              <a:ln w="11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581760" y="23259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581760" y="21060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581760" y="19749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581760" y="187452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581760" y="18036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581760" y="174348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581760" y="169272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581760" y="16527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581760" y="16128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581760" y="158364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581760" y="13521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581760" y="122148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581760" y="11322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581760" y="106128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581760" y="10011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581760" y="95004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581760" y="91008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581760" y="87012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581760" y="8298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581760" y="60984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581760" y="4788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581760" y="3891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581760" y="30924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581760" y="24912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581760" y="20916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581760" y="15840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581760" y="11808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581760" y="87480"/>
                <a:ext cx="30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581760" y="232596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581760" y="158364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581760" y="82980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581760" y="87480"/>
                <a:ext cx="40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 flipV="1">
                <a:off x="5817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V="1">
                <a:off x="70488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 flipV="1">
                <a:off x="8262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flipV="1">
                <a:off x="9576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 flipV="1">
                <a:off x="10803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 flipV="1">
                <a:off x="120204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 flipV="1">
                <a:off x="132372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 flipV="1">
                <a:off x="14454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 flipV="1">
                <a:off x="157788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 flipV="1">
                <a:off x="16995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 flipV="1">
                <a:off x="182088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 flipV="1">
                <a:off x="19425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 flipV="1">
                <a:off x="206424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 flipV="1">
                <a:off x="21963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 flipV="1">
                <a:off x="231804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 flipV="1">
                <a:off x="24393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 flipV="1">
                <a:off x="256284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 flipV="1">
                <a:off x="268452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 flipV="1">
                <a:off x="28152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 flipV="1">
                <a:off x="293832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 flipV="1">
                <a:off x="30600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 flipV="1">
                <a:off x="318132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 flipV="1">
                <a:off x="33030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 flipV="1">
                <a:off x="343548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 flipV="1">
                <a:off x="355716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 flipV="1">
                <a:off x="367884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 flipV="1">
                <a:off x="380052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 flipV="1">
                <a:off x="392184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 flipV="1">
                <a:off x="405432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V="1">
                <a:off x="417600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 flipV="1">
                <a:off x="4297680" y="2286000"/>
                <a:ext cx="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418320" y="224604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334440" y="150300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212400" y="749880"/>
                <a:ext cx="32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108720" y="44280"/>
                <a:ext cx="44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 rot="16200000">
                <a:off x="538200" y="243432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 rot="16200000">
                <a:off x="792360" y="243432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 rot="16200000">
                <a:off x="1037160" y="243432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 rot="16200000">
                <a:off x="1280160" y="2434320"/>
                <a:ext cx="192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 rot="16200000">
                <a:off x="150228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 rot="16200000">
                <a:off x="174492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 rot="16200000">
                <a:off x="200376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 rot="16200000">
                <a:off x="224892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 rot="16200000">
                <a:off x="249192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 rot="16200000">
                <a:off x="274428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 rot="16200000">
                <a:off x="298908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 rot="16200000">
                <a:off x="324288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 rot="16200000">
                <a:off x="348624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 rot="16200000">
                <a:off x="372960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 rot="16200000">
                <a:off x="3957120" y="2460960"/>
                <a:ext cx="25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 rot="16200000">
                <a:off x="4066200" y="2496960"/>
                <a:ext cx="328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&gt;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1262880" y="2651400"/>
                <a:ext cx="2262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</a:rPr>
                  <a:t>Length of predicted CDS (bp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-68040" y="666720"/>
                <a:ext cx="362880" cy="1118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Number of CD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07" name=""/>
            <p:cNvSpPr/>
            <p:nvPr/>
          </p:nvSpPr>
          <p:spPr>
            <a:xfrm>
              <a:off x="3635280" y="181080"/>
              <a:ext cx="432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08" name=""/>
          <p:cNvGrpSpPr/>
          <p:nvPr/>
        </p:nvGrpSpPr>
        <p:grpSpPr>
          <a:xfrm>
            <a:off x="4471200" y="61920"/>
            <a:ext cx="4733280" cy="3152880"/>
            <a:chOff x="4471200" y="61920"/>
            <a:chExt cx="4733280" cy="3152880"/>
          </a:xfrm>
        </p:grpSpPr>
        <p:sp>
          <p:nvSpPr>
            <p:cNvPr id="409" name=""/>
            <p:cNvSpPr/>
            <p:nvPr/>
          </p:nvSpPr>
          <p:spPr>
            <a:xfrm>
              <a:off x="5091120" y="133200"/>
              <a:ext cx="3979800" cy="2455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5091120" y="2101680"/>
              <a:ext cx="3979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5091120" y="1604880"/>
              <a:ext cx="3979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5091120" y="1117440"/>
              <a:ext cx="3979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5091120" y="620640"/>
              <a:ext cx="3979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5091120" y="133200"/>
              <a:ext cx="3979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5091120" y="133200"/>
              <a:ext cx="3979800" cy="2455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5140440" y="315720"/>
              <a:ext cx="50760" cy="227340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5243400" y="1422360"/>
              <a:ext cx="60480" cy="11667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5375160" y="1584360"/>
              <a:ext cx="50760" cy="10047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5497560" y="1595160"/>
              <a:ext cx="50760" cy="9939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5619600" y="1544400"/>
              <a:ext cx="51120" cy="10447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5740560" y="1676160"/>
              <a:ext cx="61920" cy="9129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5872320" y="1625400"/>
              <a:ext cx="50760" cy="9637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5994360" y="1655640"/>
              <a:ext cx="50760" cy="9334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6116760" y="1706400"/>
              <a:ext cx="50760" cy="8827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6238800" y="1787400"/>
              <a:ext cx="60480" cy="8017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6370560" y="1726920"/>
              <a:ext cx="50760" cy="86220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6492960" y="1817640"/>
              <a:ext cx="50760" cy="7714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6613560" y="1796760"/>
              <a:ext cx="50760" cy="7923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6735600" y="1838160"/>
              <a:ext cx="60480" cy="7509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6867360" y="1868400"/>
              <a:ext cx="51120" cy="7207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6989760" y="1909800"/>
              <a:ext cx="50760" cy="6793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7112160" y="1930320"/>
              <a:ext cx="50760" cy="65880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7232760" y="1909800"/>
              <a:ext cx="61920" cy="6793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7365960" y="1979640"/>
              <a:ext cx="50760" cy="6094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7486560" y="2101680"/>
              <a:ext cx="50760" cy="48744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7608960" y="1979640"/>
              <a:ext cx="50760" cy="6094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7731000" y="2122200"/>
              <a:ext cx="60480" cy="4669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7862760" y="2143080"/>
              <a:ext cx="50760" cy="44604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7985160" y="2203200"/>
              <a:ext cx="50760" cy="3859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8107200" y="2244600"/>
              <a:ext cx="51120" cy="34452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8228160" y="2295360"/>
              <a:ext cx="61920" cy="29376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8481960" y="2355840"/>
              <a:ext cx="50760" cy="23328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5091120" y="25891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5091120" y="24368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5091120" y="23558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5091120" y="22953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5091120" y="22446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5091120" y="22032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5091120" y="21733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5091120" y="21430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5091120" y="21222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5091120" y="21016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5091120" y="19494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5091120" y="18684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5091120" y="17967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5091120" y="17571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5091120" y="17161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5091120" y="16858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5091120" y="16556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5091120" y="16254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5091120" y="16048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5091120" y="14634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5091120" y="13716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5091120" y="13111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5091120" y="12603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5091120" y="12286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5091120" y="11890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5091120" y="11588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5091120" y="11379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5091120" y="11174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5091120" y="9651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5091120" y="8841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5091120" y="8236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5091120" y="7729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5091120" y="7318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5091120" y="7016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5091120" y="6714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5091120" y="6508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5091120" y="6206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5091120" y="4791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5091120" y="3873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5091120" y="3268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5091120" y="28548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5091120" y="2444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5091120" y="20484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5091120" y="18396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5091120" y="15372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5091120" y="133200"/>
              <a:ext cx="302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5091120" y="2589120"/>
              <a:ext cx="41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5091120" y="2101680"/>
              <a:ext cx="41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5091120" y="1604880"/>
              <a:ext cx="41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5091120" y="1117440"/>
              <a:ext cx="41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5091120" y="620640"/>
              <a:ext cx="41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5091120" y="133200"/>
              <a:ext cx="41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 flipV="1">
              <a:off x="50911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 flipV="1">
              <a:off x="52135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 flipV="1">
              <a:off x="53452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 flipV="1">
              <a:off x="54673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 flipV="1">
              <a:off x="55879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 flipV="1">
              <a:off x="57103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 flipV="1">
              <a:off x="58420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 flipV="1">
              <a:off x="59641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 flipV="1">
              <a:off x="60865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 flipV="1">
              <a:off x="62071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 flipV="1">
              <a:off x="63403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 flipV="1">
              <a:off x="64612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 flipV="1">
              <a:off x="65833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 flipV="1">
              <a:off x="67057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 flipV="1">
              <a:off x="68374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 flipV="1">
              <a:off x="69595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 flipV="1">
              <a:off x="70819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 flipV="1">
              <a:off x="72025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 flipV="1">
              <a:off x="73342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 flipV="1">
              <a:off x="74563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 flipV="1">
              <a:off x="75787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 flipV="1">
              <a:off x="77011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 flipV="1">
              <a:off x="78328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 flipV="1">
              <a:off x="79549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 flipV="1">
              <a:off x="80755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 flipV="1">
              <a:off x="81979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 flipV="1">
              <a:off x="83296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 flipV="1">
              <a:off x="84517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flipV="1">
              <a:off x="85741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flipV="1">
              <a:off x="86947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flipV="1">
              <a:off x="88279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 flipV="1">
              <a:off x="894888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 flipV="1">
              <a:off x="9070920" y="254736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4939560" y="24937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4866480" y="203040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4806000" y="15332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4743720" y="1046160"/>
              <a:ext cx="25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4683240" y="54900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4622760" y="61920"/>
              <a:ext cx="38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5007600" y="2643120"/>
              <a:ext cx="332640" cy="216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5261760" y="2638440"/>
              <a:ext cx="332640" cy="36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5510880" y="2647800"/>
              <a:ext cx="332640" cy="4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577620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604260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630612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656352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6807960" y="2652480"/>
              <a:ext cx="332640" cy="4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7071480" y="2652480"/>
              <a:ext cx="332640" cy="4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733176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759528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783972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810000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836352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861768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8871840" y="2643120"/>
              <a:ext cx="332640" cy="4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6180120" y="2938320"/>
              <a:ext cx="1727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GAP (N/size of CD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4471200" y="838080"/>
              <a:ext cx="362880" cy="129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Number of CD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8461440" y="261720"/>
              <a:ext cx="431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3" name=""/>
          <p:cNvSpPr/>
          <p:nvPr/>
        </p:nvSpPr>
        <p:spPr>
          <a:xfrm>
            <a:off x="1114560" y="6539040"/>
            <a:ext cx="705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Fig. S2. Length and GAP distribution of CDS predicted by BLAST (A, B)and ESTscan (C,D)progra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9T16:22:22Z</dcterms:created>
  <dc:creator>tclsevers</dc:creator>
  <dc:description/>
  <dc:language>en-US</dc:language>
  <cp:lastModifiedBy>tclsevers</cp:lastModifiedBy>
  <dcterms:modified xsi:type="dcterms:W3CDTF">2013-01-29T16:22:29Z</dcterms:modified>
  <cp:revision>1</cp:revision>
  <dc:subject/>
  <dc:title>幻灯片 1</dc:title>
</cp:coreProperties>
</file>